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5" r:id="rId2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CA4807"/>
    <a:srgbClr val="BD4807"/>
    <a:srgbClr val="FFCCFF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54" autoAdjust="0"/>
  </p:normalViewPr>
  <p:slideViewPr>
    <p:cSldViewPr snapToGrid="0">
      <p:cViewPr>
        <p:scale>
          <a:sx n="60" d="100"/>
          <a:sy n="60" d="100"/>
        </p:scale>
        <p:origin x="-2995" y="-17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6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0162AA44-76FE-4BB4-BE7C-1937D4DA5038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5" y="4415531"/>
            <a:ext cx="5608975" cy="4183603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6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F5A1BA9B-1AA5-4574-90D1-1073991628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84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629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999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05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52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504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77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3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379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938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03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893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3231276" y="437772"/>
            <a:ext cx="580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3G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3258984" y="4924233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A3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1634835" y="5100384"/>
            <a:ext cx="739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120L</a:t>
            </a:r>
            <a:endParaRPr lang="en-US" dirty="0"/>
          </a:p>
        </p:txBody>
      </p:sp>
      <p:grpSp>
        <p:nvGrpSpPr>
          <p:cNvPr id="24" name="Group 23"/>
          <p:cNvGrpSpPr/>
          <p:nvPr/>
        </p:nvGrpSpPr>
        <p:grpSpPr>
          <a:xfrm>
            <a:off x="4022376" y="101600"/>
            <a:ext cx="1026461" cy="307777"/>
            <a:chOff x="399464" y="9433196"/>
            <a:chExt cx="1026461" cy="307777"/>
          </a:xfrm>
        </p:grpSpPr>
        <p:sp>
          <p:nvSpPr>
            <p:cNvPr id="27" name="TextBox 26"/>
            <p:cNvSpPr txBox="1"/>
            <p:nvPr/>
          </p:nvSpPr>
          <p:spPr>
            <a:xfrm>
              <a:off x="661613" y="9433196"/>
              <a:ext cx="7643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GT→AG</a:t>
              </a:r>
              <a:endParaRPr lang="en-US" sz="1400" dirty="0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399464" y="9529941"/>
              <a:ext cx="337049" cy="108000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266767" y="505485"/>
            <a:ext cx="3301959" cy="3844833"/>
            <a:chOff x="266767" y="415627"/>
            <a:chExt cx="3301959" cy="3844833"/>
          </a:xfrm>
        </p:grpSpPr>
        <p:sp>
          <p:nvSpPr>
            <p:cNvPr id="33" name="TextBox 32"/>
            <p:cNvSpPr txBox="1"/>
            <p:nvPr/>
          </p:nvSpPr>
          <p:spPr>
            <a:xfrm>
              <a:off x="1596043" y="415627"/>
              <a:ext cx="7393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F120L</a:t>
              </a:r>
              <a:endParaRPr lang="en-US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74236" y="579114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n</a:t>
              </a:r>
              <a:r>
                <a:rPr lang="en-US" sz="1200" dirty="0" smtClean="0"/>
                <a:t>=2500</a:t>
              </a:r>
              <a:endParaRPr lang="en-US" sz="1200" dirty="0"/>
            </a:p>
          </p:txBody>
        </p:sp>
        <p:grpSp>
          <p:nvGrpSpPr>
            <p:cNvPr id="41" name="Group 40"/>
            <p:cNvGrpSpPr/>
            <p:nvPr/>
          </p:nvGrpSpPr>
          <p:grpSpPr>
            <a:xfrm>
              <a:off x="266767" y="679060"/>
              <a:ext cx="3301959" cy="3581400"/>
              <a:chOff x="266767" y="679060"/>
              <a:chExt cx="3301959" cy="3581400"/>
            </a:xfrm>
          </p:grpSpPr>
          <p:pic>
            <p:nvPicPr>
              <p:cNvPr id="11" name="Picture 10" descr="https://www.hiv.lanl.gov/tmp/HYPERMUT/2339/Plot.2339.png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49" r="-1"/>
              <a:stretch/>
            </p:blipFill>
            <p:spPr bwMode="auto">
              <a:xfrm>
                <a:off x="672175" y="679060"/>
                <a:ext cx="2896551" cy="3581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9" name="Rectangle 38"/>
              <p:cNvSpPr/>
              <p:nvPr/>
            </p:nvSpPr>
            <p:spPr>
              <a:xfrm>
                <a:off x="266767" y="755304"/>
                <a:ext cx="212128" cy="12052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1" name="TextBox 50"/>
            <p:cNvSpPr txBox="1"/>
            <p:nvPr/>
          </p:nvSpPr>
          <p:spPr>
            <a:xfrm>
              <a:off x="553171" y="392197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580194" y="516567"/>
            <a:ext cx="3277805" cy="3833751"/>
            <a:chOff x="3580194" y="426709"/>
            <a:chExt cx="3277805" cy="3833751"/>
          </a:xfrm>
        </p:grpSpPr>
        <p:sp>
          <p:nvSpPr>
            <p:cNvPr id="34" name="TextBox 33"/>
            <p:cNvSpPr txBox="1"/>
            <p:nvPr/>
          </p:nvSpPr>
          <p:spPr>
            <a:xfrm>
              <a:off x="4973781" y="426709"/>
              <a:ext cx="5020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WT</a:t>
              </a:r>
              <a:endParaRPr lang="en-US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961424" y="580104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n</a:t>
              </a:r>
              <a:r>
                <a:rPr lang="en-US" sz="1200" dirty="0" smtClean="0"/>
                <a:t>=2500</a:t>
              </a:r>
              <a:endParaRPr lang="en-US" sz="1200" dirty="0"/>
            </a:p>
          </p:txBody>
        </p:sp>
        <p:grpSp>
          <p:nvGrpSpPr>
            <p:cNvPr id="42" name="Group 41"/>
            <p:cNvGrpSpPr/>
            <p:nvPr/>
          </p:nvGrpSpPr>
          <p:grpSpPr>
            <a:xfrm>
              <a:off x="3580194" y="679060"/>
              <a:ext cx="3277805" cy="3581400"/>
              <a:chOff x="3580194" y="679060"/>
              <a:chExt cx="3277805" cy="3581400"/>
            </a:xfrm>
          </p:grpSpPr>
          <p:pic>
            <p:nvPicPr>
              <p:cNvPr id="5" name="Picture 4" descr="https://www.hiv.lanl.gov/tmp/HYPERMUT/23626/Plot.23626.png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15"/>
              <a:stretch/>
            </p:blipFill>
            <p:spPr bwMode="auto">
              <a:xfrm>
                <a:off x="3960380" y="679060"/>
                <a:ext cx="2897619" cy="3581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0" name="Rectangle 39"/>
              <p:cNvSpPr/>
              <p:nvPr/>
            </p:nvSpPr>
            <p:spPr>
              <a:xfrm>
                <a:off x="3580194" y="747001"/>
                <a:ext cx="212128" cy="12052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2" name="TextBox 51"/>
            <p:cNvSpPr txBox="1"/>
            <p:nvPr/>
          </p:nvSpPr>
          <p:spPr>
            <a:xfrm>
              <a:off x="3870646" y="391657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3576174" y="5123342"/>
            <a:ext cx="3281826" cy="3826463"/>
            <a:chOff x="3576174" y="4459008"/>
            <a:chExt cx="3281826" cy="3826463"/>
          </a:xfrm>
        </p:grpSpPr>
        <p:sp>
          <p:nvSpPr>
            <p:cNvPr id="32" name="TextBox 31"/>
            <p:cNvSpPr txBox="1"/>
            <p:nvPr/>
          </p:nvSpPr>
          <p:spPr>
            <a:xfrm>
              <a:off x="4994760" y="4459008"/>
              <a:ext cx="5020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WT</a:t>
              </a:r>
              <a:endParaRPr lang="en-US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985004" y="4603511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n</a:t>
              </a:r>
              <a:r>
                <a:rPr lang="en-US" sz="1200" dirty="0" smtClean="0"/>
                <a:t>=2500</a:t>
              </a:r>
              <a:endParaRPr lang="en-US" sz="1200" dirty="0"/>
            </a:p>
          </p:txBody>
        </p:sp>
        <p:grpSp>
          <p:nvGrpSpPr>
            <p:cNvPr id="45" name="Group 44"/>
            <p:cNvGrpSpPr/>
            <p:nvPr/>
          </p:nvGrpSpPr>
          <p:grpSpPr>
            <a:xfrm>
              <a:off x="3576174" y="4704071"/>
              <a:ext cx="3281826" cy="3581400"/>
              <a:chOff x="3576174" y="5745703"/>
              <a:chExt cx="3281826" cy="3581400"/>
            </a:xfrm>
          </p:grpSpPr>
          <p:pic>
            <p:nvPicPr>
              <p:cNvPr id="14" name="Picture 13" descr="https://www.hiv.lanl.gov/tmp/HYPERMUT/6086/Plot.6086.png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65"/>
              <a:stretch/>
            </p:blipFill>
            <p:spPr bwMode="auto">
              <a:xfrm>
                <a:off x="3984604" y="5745703"/>
                <a:ext cx="2873396" cy="3581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4" name="Rectangle 43"/>
              <p:cNvSpPr/>
              <p:nvPr/>
            </p:nvSpPr>
            <p:spPr>
              <a:xfrm>
                <a:off x="3576174" y="5800554"/>
                <a:ext cx="212128" cy="12052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3" name="TextBox 52"/>
            <p:cNvSpPr txBox="1"/>
            <p:nvPr/>
          </p:nvSpPr>
          <p:spPr>
            <a:xfrm>
              <a:off x="3870646" y="793455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10664" y="5266509"/>
            <a:ext cx="3358062" cy="3683296"/>
            <a:chOff x="210664" y="4602175"/>
            <a:chExt cx="3358062" cy="3683296"/>
          </a:xfrm>
        </p:grpSpPr>
        <p:sp>
          <p:nvSpPr>
            <p:cNvPr id="38" name="TextBox 37"/>
            <p:cNvSpPr txBox="1"/>
            <p:nvPr/>
          </p:nvSpPr>
          <p:spPr>
            <a:xfrm>
              <a:off x="694946" y="4602175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n=2215</a:t>
              </a:r>
              <a:endParaRPr lang="en-US" sz="1200" dirty="0"/>
            </a:p>
          </p:txBody>
        </p:sp>
        <p:grpSp>
          <p:nvGrpSpPr>
            <p:cNvPr id="46" name="Group 45"/>
            <p:cNvGrpSpPr/>
            <p:nvPr/>
          </p:nvGrpSpPr>
          <p:grpSpPr>
            <a:xfrm>
              <a:off x="210664" y="4704071"/>
              <a:ext cx="3358062" cy="3581400"/>
              <a:chOff x="210664" y="5745703"/>
              <a:chExt cx="3358062" cy="3581400"/>
            </a:xfrm>
          </p:grpSpPr>
          <p:pic>
            <p:nvPicPr>
              <p:cNvPr id="8" name="Picture 7" descr="https://www.hiv.lanl.gov/tmp/HYPERMUT/19007/Plot.19007.png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10"/>
              <a:stretch/>
            </p:blipFill>
            <p:spPr bwMode="auto">
              <a:xfrm>
                <a:off x="690341" y="5745703"/>
                <a:ext cx="2878385" cy="3581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3" name="Rectangle 42"/>
              <p:cNvSpPr/>
              <p:nvPr/>
            </p:nvSpPr>
            <p:spPr>
              <a:xfrm>
                <a:off x="210664" y="5821106"/>
                <a:ext cx="212128" cy="12052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4" name="TextBox 53"/>
            <p:cNvSpPr txBox="1"/>
            <p:nvPr/>
          </p:nvSpPr>
          <p:spPr>
            <a:xfrm>
              <a:off x="553171" y="793455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</p:grpSp>
      <p:sp>
        <p:nvSpPr>
          <p:cNvPr id="55" name="TextBox 54"/>
          <p:cNvSpPr txBox="1"/>
          <p:nvPr/>
        </p:nvSpPr>
        <p:spPr>
          <a:xfrm>
            <a:off x="6069001" y="9505890"/>
            <a:ext cx="7889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S5 </a:t>
            </a:r>
            <a:r>
              <a:rPr lang="en-US" sz="2000" dirty="0"/>
              <a:t>Fig</a:t>
            </a:r>
          </a:p>
        </p:txBody>
      </p:sp>
      <p:grpSp>
        <p:nvGrpSpPr>
          <p:cNvPr id="56" name="Group 55"/>
          <p:cNvGrpSpPr/>
          <p:nvPr/>
        </p:nvGrpSpPr>
        <p:grpSpPr>
          <a:xfrm>
            <a:off x="716500" y="101600"/>
            <a:ext cx="1053007" cy="307777"/>
            <a:chOff x="399464" y="9128396"/>
            <a:chExt cx="1053007" cy="307777"/>
          </a:xfrm>
        </p:grpSpPr>
        <p:sp>
          <p:nvSpPr>
            <p:cNvPr id="57" name="TextBox 56"/>
            <p:cNvSpPr txBox="1"/>
            <p:nvPr/>
          </p:nvSpPr>
          <p:spPr>
            <a:xfrm>
              <a:off x="661613" y="9128396"/>
              <a:ext cx="7908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GG→AG</a:t>
              </a:r>
              <a:endParaRPr lang="en-US" sz="1400" dirty="0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399464" y="9225141"/>
              <a:ext cx="337049" cy="108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2134995" y="101600"/>
            <a:ext cx="1035118" cy="307777"/>
            <a:chOff x="399464" y="9280796"/>
            <a:chExt cx="1035118" cy="307777"/>
          </a:xfrm>
        </p:grpSpPr>
        <p:sp>
          <p:nvSpPr>
            <p:cNvPr id="67" name="TextBox 66"/>
            <p:cNvSpPr txBox="1"/>
            <p:nvPr/>
          </p:nvSpPr>
          <p:spPr>
            <a:xfrm>
              <a:off x="661613" y="9280796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GA→AA</a:t>
              </a:r>
              <a:endParaRPr lang="en-US" sz="1400" dirty="0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99464" y="9377541"/>
              <a:ext cx="337049" cy="108000"/>
            </a:xfrm>
            <a:prstGeom prst="rect">
              <a:avLst/>
            </a:prstGeom>
            <a:solidFill>
              <a:srgbClr val="00FF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5558100" y="101600"/>
            <a:ext cx="1017740" cy="307777"/>
            <a:chOff x="399464" y="9585596"/>
            <a:chExt cx="1017740" cy="307777"/>
          </a:xfrm>
        </p:grpSpPr>
        <p:sp>
          <p:nvSpPr>
            <p:cNvPr id="72" name="TextBox 71"/>
            <p:cNvSpPr txBox="1"/>
            <p:nvPr/>
          </p:nvSpPr>
          <p:spPr>
            <a:xfrm>
              <a:off x="661613" y="9585596"/>
              <a:ext cx="7555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GC→AC</a:t>
              </a:r>
              <a:endParaRPr lang="en-US" sz="1400" dirty="0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99464" y="9682341"/>
              <a:ext cx="337049" cy="1080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8435613"/>
              </p:ext>
            </p:extLst>
          </p:nvPr>
        </p:nvGraphicFramePr>
        <p:xfrm>
          <a:off x="4106985" y="4388437"/>
          <a:ext cx="2184400" cy="4921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98500"/>
                <a:gridCol w="495300"/>
                <a:gridCol w="495300"/>
                <a:gridCol w="495300"/>
              </a:tblGrid>
              <a:tr h="309245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number mutations/ sequence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0-5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6-10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&gt;10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% sequences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99.2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0.8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4337833"/>
              </p:ext>
            </p:extLst>
          </p:nvPr>
        </p:nvGraphicFramePr>
        <p:xfrm>
          <a:off x="798635" y="4388437"/>
          <a:ext cx="2247900" cy="49974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62000"/>
                <a:gridCol w="495300"/>
                <a:gridCol w="495300"/>
                <a:gridCol w="495300"/>
              </a:tblGrid>
              <a:tr h="316865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number mutations/ sequence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0-5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6-10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&gt;10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% sequences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88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91938"/>
              </p:ext>
            </p:extLst>
          </p:nvPr>
        </p:nvGraphicFramePr>
        <p:xfrm>
          <a:off x="4106985" y="8995776"/>
          <a:ext cx="2184400" cy="4876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98500"/>
                <a:gridCol w="495300"/>
                <a:gridCol w="495300"/>
                <a:gridCol w="495300"/>
              </a:tblGrid>
              <a:tr h="260985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number mutations/ sequence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0-5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6-10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&gt;10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% sequences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97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2.6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0.4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5348208"/>
              </p:ext>
            </p:extLst>
          </p:nvPr>
        </p:nvGraphicFramePr>
        <p:xfrm>
          <a:off x="798635" y="8995776"/>
          <a:ext cx="2247900" cy="4876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62000"/>
                <a:gridCol w="495300"/>
                <a:gridCol w="495300"/>
                <a:gridCol w="495300"/>
              </a:tblGrid>
              <a:tr h="274955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number mutations/ sequence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0-5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6-10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&gt;10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% sequences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98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chemeClr val="tx1"/>
                          </a:solidFill>
                          <a:effectLst/>
                        </a:rPr>
                        <a:t>1.4</a:t>
                      </a:r>
                      <a:endParaRPr lang="en-US" sz="1100" b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tx1"/>
                          </a:solidFill>
                          <a:effectLst/>
                        </a:rPr>
                        <a:t>0.5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88604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271</TotalTime>
  <Words>80</Words>
  <Application>Microsoft Office PowerPoint</Application>
  <PresentationFormat>A4 Paper (210x297 mm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tin35</dc:creator>
  <cp:lastModifiedBy>ustin35</cp:lastModifiedBy>
  <cp:revision>498</cp:revision>
  <cp:lastPrinted>2018-11-22T13:17:53Z</cp:lastPrinted>
  <dcterms:created xsi:type="dcterms:W3CDTF">2016-04-13T08:19:07Z</dcterms:created>
  <dcterms:modified xsi:type="dcterms:W3CDTF">2019-01-02T14:03:14Z</dcterms:modified>
</cp:coreProperties>
</file>